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5335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2852D4-7FC2-423B-9666-71C92E7FA3B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475920"/>
            <a:ext cx="5829120" cy="88884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ctr">
            <a:noAutofit/>
          </a:bodyPr>
          <a:p>
            <a:pPr indent="0" algn="ctr">
              <a:buNone/>
              <a:tabLst>
                <a:tab algn="l" pos="0"/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endParaRPr b="0" lang="en-US" sz="4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1542960"/>
            <a:ext cx="5829120" cy="152640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3214800"/>
            <a:ext cx="5829120" cy="152640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5B3932-B240-45EC-8535-054F394C83E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475920"/>
            <a:ext cx="5829120" cy="88884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ctr">
            <a:noAutofit/>
          </a:bodyPr>
          <a:p>
            <a:pPr indent="0" algn="ctr">
              <a:buNone/>
              <a:tabLst>
                <a:tab algn="l" pos="0"/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endParaRPr b="0" lang="en-US" sz="4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1542960"/>
            <a:ext cx="2844360" cy="152640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1542960"/>
            <a:ext cx="2844360" cy="152640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3214800"/>
            <a:ext cx="2844360" cy="152640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3214800"/>
            <a:ext cx="2844360" cy="152640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0F5903-F48A-45F9-BC86-6E71DA3B1BF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475920"/>
            <a:ext cx="5829120" cy="88884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ctr">
            <a:noAutofit/>
          </a:bodyPr>
          <a:p>
            <a:pPr indent="0" algn="ctr">
              <a:buNone/>
              <a:tabLst>
                <a:tab algn="l" pos="0"/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endParaRPr b="0" lang="en-US" sz="4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1542960"/>
            <a:ext cx="1876680" cy="152640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1542960"/>
            <a:ext cx="1876680" cy="152640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1542960"/>
            <a:ext cx="1876680" cy="152640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3214800"/>
            <a:ext cx="1876680" cy="152640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3214800"/>
            <a:ext cx="1876680" cy="152640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3214800"/>
            <a:ext cx="1876680" cy="152640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BCDFF9-138C-4FF9-8923-822D0791CE4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475920"/>
            <a:ext cx="5829120" cy="88884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ctr">
            <a:noAutofit/>
          </a:bodyPr>
          <a:p>
            <a:pPr indent="0" algn="ctr">
              <a:buNone/>
              <a:tabLst>
                <a:tab algn="l" pos="0"/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endParaRPr b="0" lang="en-US" sz="4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1542960"/>
            <a:ext cx="5829120" cy="3200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51"/>
              </a:spcBef>
              <a:buNone/>
              <a:tabLst>
                <a:tab algn="l" pos="0"/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221BED-C31D-4861-963C-33F474BE9D3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475920"/>
            <a:ext cx="5829120" cy="88884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ctr">
            <a:noAutofit/>
          </a:bodyPr>
          <a:p>
            <a:pPr indent="0" algn="ctr">
              <a:buNone/>
              <a:tabLst>
                <a:tab algn="l" pos="0"/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endParaRPr b="0" lang="en-US" sz="4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1542960"/>
            <a:ext cx="5829120" cy="320040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DA4D7E-A3A8-49BA-A2DA-0B767033A3A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475920"/>
            <a:ext cx="5829120" cy="88884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ctr">
            <a:noAutofit/>
          </a:bodyPr>
          <a:p>
            <a:pPr indent="0" algn="ctr">
              <a:buNone/>
              <a:tabLst>
                <a:tab algn="l" pos="0"/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endParaRPr b="0" lang="en-US" sz="4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1542960"/>
            <a:ext cx="2844360" cy="320040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1542960"/>
            <a:ext cx="2844360" cy="320040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738ECC-5DFE-4A2A-8FFB-00DC4A15B2D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475920"/>
            <a:ext cx="5829120" cy="88884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ctr">
            <a:noAutofit/>
          </a:bodyPr>
          <a:p>
            <a:pPr indent="0" algn="ctr">
              <a:buNone/>
              <a:tabLst>
                <a:tab algn="l" pos="0"/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endParaRPr b="0" lang="en-US" sz="4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DD1016-8EC1-467A-9B7E-4DA7DA4C12C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475920"/>
            <a:ext cx="5829120" cy="412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51"/>
              </a:spcBef>
              <a:tabLst>
                <a:tab algn="l" pos="0"/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8AF85B-0090-4C0B-9A48-F4E6056CD75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475920"/>
            <a:ext cx="5829120" cy="88884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ctr">
            <a:noAutofit/>
          </a:bodyPr>
          <a:p>
            <a:pPr indent="0" algn="ctr">
              <a:buNone/>
              <a:tabLst>
                <a:tab algn="l" pos="0"/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endParaRPr b="0" lang="en-US" sz="4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1542960"/>
            <a:ext cx="2844360" cy="152640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1542960"/>
            <a:ext cx="2844360" cy="320040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3214800"/>
            <a:ext cx="2844360" cy="152640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48FCB0-953A-47CB-A85E-26E7F17E460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475920"/>
            <a:ext cx="5829120" cy="88884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ctr">
            <a:noAutofit/>
          </a:bodyPr>
          <a:p>
            <a:pPr indent="0" algn="ctr">
              <a:buNone/>
              <a:tabLst>
                <a:tab algn="l" pos="0"/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endParaRPr b="0" lang="en-US" sz="4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1542960"/>
            <a:ext cx="2844360" cy="320040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1542960"/>
            <a:ext cx="2844360" cy="152640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3214800"/>
            <a:ext cx="2844360" cy="152640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86DFB1-F46A-48D0-B571-3C138972F9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475920"/>
            <a:ext cx="5829120" cy="88884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ctr">
            <a:noAutofit/>
          </a:bodyPr>
          <a:p>
            <a:pPr indent="0" algn="ctr">
              <a:buNone/>
              <a:tabLst>
                <a:tab algn="l" pos="0"/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endParaRPr b="0" lang="en-US" sz="4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1542960"/>
            <a:ext cx="2844360" cy="152640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1542960"/>
            <a:ext cx="2844360" cy="152640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3214800"/>
            <a:ext cx="5829120" cy="152640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/>
          </a:bodyPr>
          <a:p>
            <a:pPr indent="0">
              <a:spcBef>
                <a:spcPts val="751"/>
              </a:spcBef>
              <a:buNone/>
              <a:tabLst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3DBFC9-88F1-404D-99DC-BDD258B38D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475920"/>
            <a:ext cx="5829120" cy="88884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ctr">
            <a:noAutofit/>
          </a:bodyPr>
          <a:p>
            <a:pPr indent="0" algn="ctr">
              <a:buNone/>
              <a:tabLst>
                <a:tab algn="l" pos="0"/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r>
              <a:rPr b="0" lang="en-US" sz="41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1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1542960"/>
            <a:ext cx="5829120" cy="320040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rmAutofit fontScale="82000"/>
          </a:bodyPr>
          <a:p>
            <a:pPr marL="262800" indent="-262800">
              <a:spcBef>
                <a:spcPts val="751"/>
              </a:spcBef>
              <a:buClr>
                <a:srgbClr val="000000"/>
              </a:buClr>
              <a:buFont typeface="Times New Roman"/>
              <a:buChar char="•"/>
              <a:tabLst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  <a:p>
            <a:pPr lvl="1" marL="569880" indent="-219600">
              <a:spcBef>
                <a:spcPts val="751"/>
              </a:spcBef>
              <a:buClr>
                <a:srgbClr val="000000"/>
              </a:buClr>
              <a:buFont typeface="Times New Roman"/>
              <a:buChar char="–"/>
              <a:tabLst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  <a:p>
            <a:pPr lvl="2" marL="877320" indent="-175320">
              <a:spcBef>
                <a:spcPts val="751"/>
              </a:spcBef>
              <a:buClr>
                <a:srgbClr val="000000"/>
              </a:buClr>
              <a:buFont typeface="Times New Roman"/>
              <a:buChar char="•"/>
              <a:tabLst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  <a:p>
            <a:pPr lvl="3" marL="1227240" indent="-175320">
              <a:spcBef>
                <a:spcPts val="751"/>
              </a:spcBef>
              <a:buClr>
                <a:srgbClr val="000000"/>
              </a:buClr>
              <a:buFont typeface="Times New Roman"/>
              <a:buChar char="–"/>
              <a:tabLst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  <a:p>
            <a:pPr lvl="4" marL="1578960" indent="-175320">
              <a:spcBef>
                <a:spcPts val="751"/>
              </a:spcBef>
              <a:buClr>
                <a:srgbClr val="000000"/>
              </a:buClr>
              <a:buFont typeface="Times New Roman"/>
              <a:buChar char="»"/>
              <a:tabLst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  <a:p>
            <a:pPr lvl="5" marL="1578960" indent="-175320">
              <a:spcBef>
                <a:spcPts val="751"/>
              </a:spcBef>
              <a:buClr>
                <a:srgbClr val="000000"/>
              </a:buClr>
              <a:buFont typeface="Times New Roman"/>
              <a:buChar char="»"/>
              <a:tabLst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  <a:p>
            <a:pPr lvl="6" marL="1578960" indent="-175320">
              <a:spcBef>
                <a:spcPts val="751"/>
              </a:spcBef>
              <a:buClr>
                <a:srgbClr val="000000"/>
              </a:buClr>
              <a:buFont typeface="Times New Roman"/>
              <a:buChar char="»"/>
              <a:tabLst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r>
              <a:rPr b="0" lang="en-US" sz="30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4857840"/>
            <a:ext cx="1428840" cy="35568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4857840"/>
            <a:ext cx="2171520" cy="35568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4857840"/>
            <a:ext cx="1428480" cy="355680"/>
          </a:xfrm>
          <a:prstGeom prst="rect">
            <a:avLst/>
          </a:prstGeom>
          <a:noFill/>
          <a:ln w="0">
            <a:noFill/>
          </a:ln>
        </p:spPr>
        <p:txBody>
          <a:bodyPr lIns="85680" rIns="85680" tIns="42840" bIns="42840" anchor="t">
            <a:noAutofit/>
          </a:bodyPr>
          <a:lstStyle>
            <a:lvl1pPr indent="0" algn="r">
              <a:buNone/>
              <a:tabLst>
                <a:tab algn="l" pos="0"/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  <a:defRPr b="0" lang="en-US" sz="13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855720"/>
                <a:tab algn="l" pos="1711440"/>
                <a:tab algn="l" pos="2567160"/>
                <a:tab algn="l" pos="3422520"/>
                <a:tab algn="l" pos="4278240"/>
                <a:tab algn="l" pos="5133960"/>
                <a:tab algn="l" pos="5989680"/>
                <a:tab algn="l" pos="6845400"/>
                <a:tab algn="l" pos="7701120"/>
                <a:tab algn="l" pos="8556480"/>
                <a:tab algn="l" pos="9412200"/>
                <a:tab algn="l" pos="10267920"/>
              </a:tabLst>
            </a:pPr>
            <a:fld id="{52678F63-24F1-498C-AED7-B2F9A351B0F7}" type="slidenum"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69"/>
          <p:cNvGrpSpPr/>
          <p:nvPr/>
        </p:nvGrpSpPr>
        <p:grpSpPr>
          <a:xfrm>
            <a:off x="504720" y="533520"/>
            <a:ext cx="5869080" cy="4132800"/>
            <a:chOff x="504720" y="533520"/>
            <a:chExt cx="5869080" cy="4132800"/>
          </a:xfrm>
        </p:grpSpPr>
        <p:sp>
          <p:nvSpPr>
            <p:cNvPr id="42" name="Text Box 121"/>
            <p:cNvSpPr/>
            <p:nvPr/>
          </p:nvSpPr>
          <p:spPr>
            <a:xfrm>
              <a:off x="5506920" y="4359240"/>
              <a:ext cx="685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X (1)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" name="Oval 4"/>
            <p:cNvSpPr/>
            <p:nvPr/>
          </p:nvSpPr>
          <p:spPr>
            <a:xfrm>
              <a:off x="2265480" y="1418040"/>
              <a:ext cx="718920" cy="718920"/>
            </a:xfrm>
            <a:prstGeom prst="ellipse">
              <a:avLst/>
            </a:pr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" name="Oval 5"/>
            <p:cNvSpPr/>
            <p:nvPr/>
          </p:nvSpPr>
          <p:spPr>
            <a:xfrm>
              <a:off x="1060560" y="2426400"/>
              <a:ext cx="539640" cy="53964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Oval 9"/>
            <p:cNvSpPr/>
            <p:nvPr/>
          </p:nvSpPr>
          <p:spPr>
            <a:xfrm>
              <a:off x="1825560" y="1309680"/>
              <a:ext cx="71640" cy="7128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Line 10"/>
            <p:cNvSpPr/>
            <p:nvPr/>
          </p:nvSpPr>
          <p:spPr>
            <a:xfrm>
              <a:off x="1863720" y="1386360"/>
              <a:ext cx="0" cy="360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Line 11"/>
            <p:cNvSpPr/>
            <p:nvPr/>
          </p:nvSpPr>
          <p:spPr>
            <a:xfrm>
              <a:off x="1863720" y="947880"/>
              <a:ext cx="0" cy="360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Oval 12"/>
            <p:cNvSpPr/>
            <p:nvPr/>
          </p:nvSpPr>
          <p:spPr>
            <a:xfrm>
              <a:off x="1825560" y="1743480"/>
              <a:ext cx="71640" cy="7128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Oval 15"/>
            <p:cNvSpPr/>
            <p:nvPr/>
          </p:nvSpPr>
          <p:spPr>
            <a:xfrm>
              <a:off x="1825560" y="866880"/>
              <a:ext cx="71640" cy="7128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Oval 19"/>
            <p:cNvSpPr/>
            <p:nvPr/>
          </p:nvSpPr>
          <p:spPr>
            <a:xfrm>
              <a:off x="928800" y="622440"/>
              <a:ext cx="539640" cy="539640"/>
            </a:xfrm>
            <a:prstGeom prst="ellipse">
              <a:avLst/>
            </a:pr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Line 22"/>
            <p:cNvSpPr/>
            <p:nvPr/>
          </p:nvSpPr>
          <p:spPr>
            <a:xfrm>
              <a:off x="1469880" y="896760"/>
              <a:ext cx="360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Line 23"/>
            <p:cNvSpPr/>
            <p:nvPr/>
          </p:nvSpPr>
          <p:spPr>
            <a:xfrm>
              <a:off x="1900080" y="896760"/>
              <a:ext cx="360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Line 24"/>
            <p:cNvSpPr/>
            <p:nvPr/>
          </p:nvSpPr>
          <p:spPr>
            <a:xfrm>
              <a:off x="2346480" y="901800"/>
              <a:ext cx="35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Oval 25"/>
            <p:cNvSpPr/>
            <p:nvPr/>
          </p:nvSpPr>
          <p:spPr>
            <a:xfrm>
              <a:off x="2270160" y="863640"/>
              <a:ext cx="71280" cy="7128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Line 26"/>
            <p:cNvSpPr/>
            <p:nvPr/>
          </p:nvSpPr>
          <p:spPr>
            <a:xfrm>
              <a:off x="2776680" y="896760"/>
              <a:ext cx="35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Oval 27"/>
            <p:cNvSpPr/>
            <p:nvPr/>
          </p:nvSpPr>
          <p:spPr>
            <a:xfrm>
              <a:off x="2700360" y="858960"/>
              <a:ext cx="71280" cy="7128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Oval 28"/>
            <p:cNvSpPr/>
            <p:nvPr/>
          </p:nvSpPr>
          <p:spPr>
            <a:xfrm>
              <a:off x="3133800" y="807840"/>
              <a:ext cx="179280" cy="179640"/>
            </a:xfrm>
            <a:prstGeom prst="ellipse">
              <a:avLst/>
            </a:pr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Line 29"/>
            <p:cNvSpPr/>
            <p:nvPr/>
          </p:nvSpPr>
          <p:spPr>
            <a:xfrm>
              <a:off x="3309840" y="901800"/>
              <a:ext cx="360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Line 30"/>
            <p:cNvSpPr/>
            <p:nvPr/>
          </p:nvSpPr>
          <p:spPr>
            <a:xfrm>
              <a:off x="3753000" y="901800"/>
              <a:ext cx="35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Oval 31"/>
            <p:cNvSpPr/>
            <p:nvPr/>
          </p:nvSpPr>
          <p:spPr>
            <a:xfrm>
              <a:off x="3676680" y="863640"/>
              <a:ext cx="71280" cy="7128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Line 32"/>
            <p:cNvSpPr/>
            <p:nvPr/>
          </p:nvSpPr>
          <p:spPr>
            <a:xfrm>
              <a:off x="4187880" y="896760"/>
              <a:ext cx="35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Oval 33"/>
            <p:cNvSpPr/>
            <p:nvPr/>
          </p:nvSpPr>
          <p:spPr>
            <a:xfrm>
              <a:off x="4116240" y="858960"/>
              <a:ext cx="71640" cy="7128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Line 34"/>
            <p:cNvSpPr/>
            <p:nvPr/>
          </p:nvSpPr>
          <p:spPr>
            <a:xfrm>
              <a:off x="4610160" y="896760"/>
              <a:ext cx="35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Oval 35"/>
            <p:cNvSpPr/>
            <p:nvPr/>
          </p:nvSpPr>
          <p:spPr>
            <a:xfrm>
              <a:off x="4538520" y="858960"/>
              <a:ext cx="71640" cy="7128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Oval 37"/>
            <p:cNvSpPr/>
            <p:nvPr/>
          </p:nvSpPr>
          <p:spPr>
            <a:xfrm>
              <a:off x="4944960" y="533520"/>
              <a:ext cx="719280" cy="718920"/>
            </a:xfrm>
            <a:prstGeom prst="ellipse">
              <a:avLst/>
            </a:prstGeom>
            <a:solidFill>
              <a:srgbClr val="ffff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Oval 42"/>
            <p:cNvSpPr/>
            <p:nvPr/>
          </p:nvSpPr>
          <p:spPr>
            <a:xfrm>
              <a:off x="4397400" y="2086200"/>
              <a:ext cx="360360" cy="360360"/>
            </a:xfrm>
            <a:prstGeom prst="ellipse">
              <a:avLst/>
            </a:prstGeom>
            <a:solidFill>
              <a:srgbClr val="ff99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Oval 43"/>
            <p:cNvSpPr/>
            <p:nvPr/>
          </p:nvSpPr>
          <p:spPr>
            <a:xfrm>
              <a:off x="3676680" y="1297080"/>
              <a:ext cx="71280" cy="7128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Line 44"/>
            <p:cNvSpPr/>
            <p:nvPr/>
          </p:nvSpPr>
          <p:spPr>
            <a:xfrm>
              <a:off x="3714840" y="1376640"/>
              <a:ext cx="0" cy="333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Oval 46"/>
            <p:cNvSpPr/>
            <p:nvPr/>
          </p:nvSpPr>
          <p:spPr>
            <a:xfrm>
              <a:off x="3676680" y="1714680"/>
              <a:ext cx="71280" cy="7164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Line 47"/>
            <p:cNvSpPr/>
            <p:nvPr/>
          </p:nvSpPr>
          <p:spPr>
            <a:xfrm>
              <a:off x="3714840" y="1791000"/>
              <a:ext cx="0" cy="322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Oval 50"/>
            <p:cNvSpPr/>
            <p:nvPr/>
          </p:nvSpPr>
          <p:spPr>
            <a:xfrm>
              <a:off x="3625920" y="2109960"/>
              <a:ext cx="179280" cy="17964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Line 54"/>
            <p:cNvSpPr/>
            <p:nvPr/>
          </p:nvSpPr>
          <p:spPr>
            <a:xfrm>
              <a:off x="2462040" y="2697840"/>
              <a:ext cx="35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Oval 55"/>
            <p:cNvSpPr/>
            <p:nvPr/>
          </p:nvSpPr>
          <p:spPr>
            <a:xfrm>
              <a:off x="2390760" y="2659680"/>
              <a:ext cx="71280" cy="7164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Line 56"/>
            <p:cNvSpPr/>
            <p:nvPr/>
          </p:nvSpPr>
          <p:spPr>
            <a:xfrm>
              <a:off x="2889360" y="2697840"/>
              <a:ext cx="35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Oval 57"/>
            <p:cNvSpPr/>
            <p:nvPr/>
          </p:nvSpPr>
          <p:spPr>
            <a:xfrm>
              <a:off x="2817720" y="2659680"/>
              <a:ext cx="71640" cy="7164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Line 58"/>
            <p:cNvSpPr/>
            <p:nvPr/>
          </p:nvSpPr>
          <p:spPr>
            <a:xfrm>
              <a:off x="3317760" y="2697840"/>
              <a:ext cx="35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Oval 59"/>
            <p:cNvSpPr/>
            <p:nvPr/>
          </p:nvSpPr>
          <p:spPr>
            <a:xfrm>
              <a:off x="3246480" y="2659680"/>
              <a:ext cx="71280" cy="7164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Line 60"/>
            <p:cNvSpPr/>
            <p:nvPr/>
          </p:nvSpPr>
          <p:spPr>
            <a:xfrm>
              <a:off x="3719520" y="2291400"/>
              <a:ext cx="0" cy="360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Oval 61"/>
            <p:cNvSpPr/>
            <p:nvPr/>
          </p:nvSpPr>
          <p:spPr>
            <a:xfrm>
              <a:off x="3681360" y="2659680"/>
              <a:ext cx="71640" cy="7164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Line 62"/>
            <p:cNvSpPr/>
            <p:nvPr/>
          </p:nvSpPr>
          <p:spPr>
            <a:xfrm>
              <a:off x="3755880" y="2697840"/>
              <a:ext cx="35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" name="Oval 64"/>
            <p:cNvSpPr/>
            <p:nvPr/>
          </p:nvSpPr>
          <p:spPr>
            <a:xfrm>
              <a:off x="4106880" y="2655000"/>
              <a:ext cx="71280" cy="7128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" name="Line 65"/>
            <p:cNvSpPr/>
            <p:nvPr/>
          </p:nvSpPr>
          <p:spPr>
            <a:xfrm>
              <a:off x="4187880" y="2693160"/>
              <a:ext cx="35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" name="Line 67"/>
            <p:cNvSpPr/>
            <p:nvPr/>
          </p:nvSpPr>
          <p:spPr>
            <a:xfrm>
              <a:off x="4621320" y="2693160"/>
              <a:ext cx="35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" name="Oval 68"/>
            <p:cNvSpPr/>
            <p:nvPr/>
          </p:nvSpPr>
          <p:spPr>
            <a:xfrm>
              <a:off x="4545000" y="2655000"/>
              <a:ext cx="71280" cy="7128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" name="Oval 69"/>
            <p:cNvSpPr/>
            <p:nvPr/>
          </p:nvSpPr>
          <p:spPr>
            <a:xfrm>
              <a:off x="4970520" y="2597760"/>
              <a:ext cx="179280" cy="17964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" name="Line 70"/>
            <p:cNvSpPr/>
            <p:nvPr/>
          </p:nvSpPr>
          <p:spPr>
            <a:xfrm>
              <a:off x="5149800" y="2693160"/>
              <a:ext cx="35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" name="Line 72"/>
            <p:cNvSpPr/>
            <p:nvPr/>
          </p:nvSpPr>
          <p:spPr>
            <a:xfrm>
              <a:off x="5587920" y="2688480"/>
              <a:ext cx="35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" name="Oval 73"/>
            <p:cNvSpPr/>
            <p:nvPr/>
          </p:nvSpPr>
          <p:spPr>
            <a:xfrm>
              <a:off x="5511960" y="2650320"/>
              <a:ext cx="71280" cy="7128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" name="Oval 74"/>
            <p:cNvSpPr/>
            <p:nvPr/>
          </p:nvSpPr>
          <p:spPr>
            <a:xfrm>
              <a:off x="5945040" y="2597760"/>
              <a:ext cx="179640" cy="17964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" name="Oval 75"/>
            <p:cNvSpPr/>
            <p:nvPr/>
          </p:nvSpPr>
          <p:spPr>
            <a:xfrm>
              <a:off x="5513400" y="3093480"/>
              <a:ext cx="71280" cy="7164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" name="Line 76"/>
            <p:cNvSpPr/>
            <p:nvPr/>
          </p:nvSpPr>
          <p:spPr>
            <a:xfrm>
              <a:off x="5551560" y="3169800"/>
              <a:ext cx="0" cy="360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" name="Line 77"/>
            <p:cNvSpPr/>
            <p:nvPr/>
          </p:nvSpPr>
          <p:spPr>
            <a:xfrm>
              <a:off x="5551560" y="2731320"/>
              <a:ext cx="0" cy="360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" name="Oval 78"/>
            <p:cNvSpPr/>
            <p:nvPr/>
          </p:nvSpPr>
          <p:spPr>
            <a:xfrm>
              <a:off x="5513400" y="3539520"/>
              <a:ext cx="71280" cy="7164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" name="Line 79"/>
            <p:cNvSpPr/>
            <p:nvPr/>
          </p:nvSpPr>
          <p:spPr>
            <a:xfrm>
              <a:off x="5551560" y="3615840"/>
              <a:ext cx="0" cy="360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" name="Oval 80"/>
            <p:cNvSpPr/>
            <p:nvPr/>
          </p:nvSpPr>
          <p:spPr>
            <a:xfrm>
              <a:off x="5513400" y="3984480"/>
              <a:ext cx="71280" cy="7128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" name="Line 81"/>
            <p:cNvSpPr/>
            <p:nvPr/>
          </p:nvSpPr>
          <p:spPr>
            <a:xfrm>
              <a:off x="5546880" y="4063680"/>
              <a:ext cx="0" cy="360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" name="Oval 82"/>
            <p:cNvSpPr/>
            <p:nvPr/>
          </p:nvSpPr>
          <p:spPr>
            <a:xfrm>
              <a:off x="5459400" y="4424040"/>
              <a:ext cx="179280" cy="17964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8" name="Oval 88"/>
            <p:cNvSpPr/>
            <p:nvPr/>
          </p:nvSpPr>
          <p:spPr>
            <a:xfrm>
              <a:off x="3746520" y="4489200"/>
              <a:ext cx="71280" cy="7164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9" name="Line 89"/>
            <p:cNvSpPr/>
            <p:nvPr/>
          </p:nvSpPr>
          <p:spPr>
            <a:xfrm>
              <a:off x="3816360" y="4527360"/>
              <a:ext cx="35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0" name="Line 90"/>
            <p:cNvSpPr/>
            <p:nvPr/>
          </p:nvSpPr>
          <p:spPr>
            <a:xfrm>
              <a:off x="4243320" y="4527360"/>
              <a:ext cx="35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1" name="Oval 91"/>
            <p:cNvSpPr/>
            <p:nvPr/>
          </p:nvSpPr>
          <p:spPr>
            <a:xfrm>
              <a:off x="4173480" y="4489200"/>
              <a:ext cx="71640" cy="7164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2" name="Line 92"/>
            <p:cNvSpPr/>
            <p:nvPr/>
          </p:nvSpPr>
          <p:spPr>
            <a:xfrm>
              <a:off x="4680000" y="4527360"/>
              <a:ext cx="35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3" name="Oval 93"/>
            <p:cNvSpPr/>
            <p:nvPr/>
          </p:nvSpPr>
          <p:spPr>
            <a:xfrm>
              <a:off x="4608360" y="4489200"/>
              <a:ext cx="71640" cy="7164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4" name="Line 94"/>
            <p:cNvSpPr/>
            <p:nvPr/>
          </p:nvSpPr>
          <p:spPr>
            <a:xfrm>
              <a:off x="5103720" y="4518000"/>
              <a:ext cx="35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5" name="Oval 95"/>
            <p:cNvSpPr/>
            <p:nvPr/>
          </p:nvSpPr>
          <p:spPr>
            <a:xfrm>
              <a:off x="5030640" y="4484520"/>
              <a:ext cx="71640" cy="7128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6" name="Line 96"/>
            <p:cNvSpPr/>
            <p:nvPr/>
          </p:nvSpPr>
          <p:spPr>
            <a:xfrm>
              <a:off x="3789360" y="3241080"/>
              <a:ext cx="0" cy="360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7" name="Oval 97"/>
            <p:cNvSpPr/>
            <p:nvPr/>
          </p:nvSpPr>
          <p:spPr>
            <a:xfrm>
              <a:off x="3751200" y="3601440"/>
              <a:ext cx="71640" cy="7164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8" name="Line 98"/>
            <p:cNvSpPr/>
            <p:nvPr/>
          </p:nvSpPr>
          <p:spPr>
            <a:xfrm>
              <a:off x="3789360" y="3677760"/>
              <a:ext cx="0" cy="360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9" name="Oval 99"/>
            <p:cNvSpPr/>
            <p:nvPr/>
          </p:nvSpPr>
          <p:spPr>
            <a:xfrm>
              <a:off x="3751200" y="4046400"/>
              <a:ext cx="71640" cy="7128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" name="Line 100"/>
            <p:cNvSpPr/>
            <p:nvPr/>
          </p:nvSpPr>
          <p:spPr>
            <a:xfrm>
              <a:off x="3784680" y="4125600"/>
              <a:ext cx="0" cy="360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1" name="Oval 101"/>
            <p:cNvSpPr/>
            <p:nvPr/>
          </p:nvSpPr>
          <p:spPr>
            <a:xfrm>
              <a:off x="3695760" y="3079080"/>
              <a:ext cx="179280" cy="17964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2" name="Line 102"/>
            <p:cNvSpPr/>
            <p:nvPr/>
          </p:nvSpPr>
          <p:spPr>
            <a:xfrm>
              <a:off x="3716280" y="942840"/>
              <a:ext cx="0" cy="360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3" name="Line 106"/>
            <p:cNvSpPr/>
            <p:nvPr/>
          </p:nvSpPr>
          <p:spPr>
            <a:xfrm>
              <a:off x="1901880" y="1778400"/>
              <a:ext cx="3603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4" name="Line 107"/>
            <p:cNvSpPr/>
            <p:nvPr/>
          </p:nvSpPr>
          <p:spPr>
            <a:xfrm>
              <a:off x="1603440" y="2697840"/>
              <a:ext cx="35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" name="Line 108"/>
            <p:cNvSpPr/>
            <p:nvPr/>
          </p:nvSpPr>
          <p:spPr>
            <a:xfrm>
              <a:off x="2030400" y="2697840"/>
              <a:ext cx="352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6" name="Oval 109"/>
            <p:cNvSpPr/>
            <p:nvPr/>
          </p:nvSpPr>
          <p:spPr>
            <a:xfrm>
              <a:off x="1959120" y="2659680"/>
              <a:ext cx="71280" cy="7164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7" name="Line 110"/>
            <p:cNvSpPr/>
            <p:nvPr/>
          </p:nvSpPr>
          <p:spPr>
            <a:xfrm>
              <a:off x="4575240" y="934920"/>
              <a:ext cx="0" cy="360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8" name="Text Box 112"/>
            <p:cNvSpPr/>
            <p:nvPr/>
          </p:nvSpPr>
          <p:spPr>
            <a:xfrm>
              <a:off x="2362320" y="1614960"/>
              <a:ext cx="5331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I (4)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9" name="Text Box 113"/>
            <p:cNvSpPr/>
            <p:nvPr/>
          </p:nvSpPr>
          <p:spPr>
            <a:xfrm>
              <a:off x="905040" y="719280"/>
              <a:ext cx="609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II (3)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0" name="Text Box 114"/>
            <p:cNvSpPr/>
            <p:nvPr/>
          </p:nvSpPr>
          <p:spPr>
            <a:xfrm>
              <a:off x="2876400" y="928800"/>
              <a:ext cx="685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III (1)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1" name="Text Box 115"/>
            <p:cNvSpPr/>
            <p:nvPr/>
          </p:nvSpPr>
          <p:spPr>
            <a:xfrm>
              <a:off x="4962600" y="736560"/>
              <a:ext cx="685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IV (4)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2" name="Text Box 116"/>
            <p:cNvSpPr/>
            <p:nvPr/>
          </p:nvSpPr>
          <p:spPr>
            <a:xfrm>
              <a:off x="4695840" y="2119680"/>
              <a:ext cx="685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V (2)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3" name="Text Box 117"/>
            <p:cNvSpPr/>
            <p:nvPr/>
          </p:nvSpPr>
          <p:spPr>
            <a:xfrm>
              <a:off x="3714840" y="2053080"/>
              <a:ext cx="685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VI (1)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4" name="Text Box 118"/>
            <p:cNvSpPr/>
            <p:nvPr/>
          </p:nvSpPr>
          <p:spPr>
            <a:xfrm>
              <a:off x="952560" y="2529720"/>
              <a:ext cx="762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VII (3)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5" name="Text Box 119"/>
            <p:cNvSpPr/>
            <p:nvPr/>
          </p:nvSpPr>
          <p:spPr>
            <a:xfrm>
              <a:off x="4649760" y="2720160"/>
              <a:ext cx="838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VIII (1)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6" name="Text Box 120"/>
            <p:cNvSpPr/>
            <p:nvPr/>
          </p:nvSpPr>
          <p:spPr>
            <a:xfrm>
              <a:off x="5688000" y="2710440"/>
              <a:ext cx="685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IX (1)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7" name="Text Box 122"/>
            <p:cNvSpPr/>
            <p:nvPr/>
          </p:nvSpPr>
          <p:spPr>
            <a:xfrm>
              <a:off x="3782880" y="3015720"/>
              <a:ext cx="685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XI (1)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8" name="Text Box 134"/>
            <p:cNvSpPr/>
            <p:nvPr/>
          </p:nvSpPr>
          <p:spPr>
            <a:xfrm>
              <a:off x="2914560" y="1475280"/>
              <a:ext cx="609840" cy="63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5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Ita08b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5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Ita10a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5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Ita10b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5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Ita11b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9" name="Text Box 135"/>
            <p:cNvSpPr/>
            <p:nvPr/>
          </p:nvSpPr>
          <p:spPr>
            <a:xfrm>
              <a:off x="5600880" y="622440"/>
              <a:ext cx="609480" cy="63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5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Ita03a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5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Ita03b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5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Ita04a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5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Ita04b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0" name="Text Box 136"/>
            <p:cNvSpPr/>
            <p:nvPr/>
          </p:nvSpPr>
          <p:spPr>
            <a:xfrm>
              <a:off x="504720" y="684360"/>
              <a:ext cx="609840" cy="480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5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Ita02b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5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Ita08a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5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Ita11a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1" name="Text Box 137"/>
            <p:cNvSpPr/>
            <p:nvPr/>
          </p:nvSpPr>
          <p:spPr>
            <a:xfrm>
              <a:off x="2914560" y="671400"/>
              <a:ext cx="60984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5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Ita02a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2" name="Text Box 138"/>
            <p:cNvSpPr/>
            <p:nvPr/>
          </p:nvSpPr>
          <p:spPr>
            <a:xfrm>
              <a:off x="4724280" y="1891080"/>
              <a:ext cx="609840" cy="325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5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Ita12a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5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Ita12b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3" name="Text Box 139"/>
            <p:cNvSpPr/>
            <p:nvPr/>
          </p:nvSpPr>
          <p:spPr>
            <a:xfrm>
              <a:off x="628560" y="2466000"/>
              <a:ext cx="609840" cy="480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5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Ita05a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5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Ita07a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5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Ita07b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4" name="Text Box 140"/>
            <p:cNvSpPr/>
            <p:nvPr/>
          </p:nvSpPr>
          <p:spPr>
            <a:xfrm>
              <a:off x="3743280" y="1986480"/>
              <a:ext cx="6094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5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Ita06a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5" name="Text Box 141"/>
            <p:cNvSpPr/>
            <p:nvPr/>
          </p:nvSpPr>
          <p:spPr>
            <a:xfrm>
              <a:off x="4745160" y="2986920"/>
              <a:ext cx="6094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5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Ita05b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6" name="Text Box 142"/>
            <p:cNvSpPr/>
            <p:nvPr/>
          </p:nvSpPr>
          <p:spPr>
            <a:xfrm>
              <a:off x="5726160" y="2986920"/>
              <a:ext cx="60948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5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Ita09b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7" name="Text Box 143"/>
            <p:cNvSpPr/>
            <p:nvPr/>
          </p:nvSpPr>
          <p:spPr>
            <a:xfrm>
              <a:off x="5592600" y="4305240"/>
              <a:ext cx="60984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5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Ita09a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8" name="Text Box 144"/>
            <p:cNvSpPr/>
            <p:nvPr/>
          </p:nvSpPr>
          <p:spPr>
            <a:xfrm>
              <a:off x="3801960" y="3301560"/>
              <a:ext cx="609840" cy="169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5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Ita06b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9" name="Oval 153"/>
            <p:cNvSpPr/>
            <p:nvPr/>
          </p:nvSpPr>
          <p:spPr>
            <a:xfrm>
              <a:off x="4538520" y="1297080"/>
              <a:ext cx="71640" cy="7128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0" name="Line 154"/>
            <p:cNvSpPr/>
            <p:nvPr/>
          </p:nvSpPr>
          <p:spPr>
            <a:xfrm>
              <a:off x="4576680" y="1364040"/>
              <a:ext cx="0" cy="333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1" name="Oval 155"/>
            <p:cNvSpPr/>
            <p:nvPr/>
          </p:nvSpPr>
          <p:spPr>
            <a:xfrm>
              <a:off x="4538520" y="1689480"/>
              <a:ext cx="71640" cy="71280"/>
            </a:xfrm>
            <a:prstGeom prst="ellipse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2" name="Line 156"/>
            <p:cNvSpPr/>
            <p:nvPr/>
          </p:nvSpPr>
          <p:spPr>
            <a:xfrm>
              <a:off x="4576680" y="1765800"/>
              <a:ext cx="0" cy="322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143" name="Group 167"/>
          <p:cNvGrpSpPr/>
          <p:nvPr/>
        </p:nvGrpSpPr>
        <p:grpSpPr>
          <a:xfrm>
            <a:off x="836640" y="3746520"/>
            <a:ext cx="1600920" cy="839520"/>
            <a:chOff x="836640" y="3746520"/>
            <a:chExt cx="1600920" cy="839520"/>
          </a:xfrm>
        </p:grpSpPr>
        <p:grpSp>
          <p:nvGrpSpPr>
            <p:cNvPr id="144" name="Group 164"/>
            <p:cNvGrpSpPr/>
            <p:nvPr/>
          </p:nvGrpSpPr>
          <p:grpSpPr>
            <a:xfrm>
              <a:off x="912600" y="3751200"/>
              <a:ext cx="1524960" cy="832320"/>
              <a:chOff x="912600" y="3751200"/>
              <a:chExt cx="1524960" cy="832320"/>
            </a:xfrm>
          </p:grpSpPr>
          <p:sp>
            <p:nvSpPr>
              <p:cNvPr id="145" name="Oval 128"/>
              <p:cNvSpPr/>
              <p:nvPr/>
            </p:nvSpPr>
            <p:spPr>
              <a:xfrm>
                <a:off x="912600" y="3808440"/>
                <a:ext cx="178920" cy="179280"/>
              </a:xfrm>
              <a:prstGeom prst="ellipse">
                <a:avLst/>
              </a:prstGeom>
              <a:solidFill>
                <a:srgbClr val="ffff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6" name="Oval 129"/>
              <p:cNvSpPr/>
              <p:nvPr/>
            </p:nvSpPr>
            <p:spPr>
              <a:xfrm>
                <a:off x="912600" y="4075560"/>
                <a:ext cx="178920" cy="179280"/>
              </a:xfrm>
              <a:prstGeom prst="ellipse">
                <a:avLst/>
              </a:prstGeom>
              <a:solidFill>
                <a:srgbClr val="ff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7" name="Text Box 130"/>
              <p:cNvSpPr/>
              <p:nvPr/>
            </p:nvSpPr>
            <p:spPr>
              <a:xfrm>
                <a:off x="1047240" y="3751200"/>
                <a:ext cx="1390320" cy="832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Itatiaia A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ItatiaiaB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Ita12a / Ita12b </a:t>
                </a:r>
                <a:endParaRPr b="0" lang="en-US" sz="12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8" name="Oval 159"/>
              <p:cNvSpPr/>
              <p:nvPr/>
            </p:nvSpPr>
            <p:spPr>
              <a:xfrm>
                <a:off x="912600" y="4334400"/>
                <a:ext cx="178920" cy="179640"/>
              </a:xfrm>
              <a:prstGeom prst="ellipse">
                <a:avLst/>
              </a:prstGeom>
              <a:solidFill>
                <a:srgbClr val="ff99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149" name="Rectangle 166"/>
            <p:cNvSpPr/>
            <p:nvPr/>
          </p:nvSpPr>
          <p:spPr>
            <a:xfrm>
              <a:off x="836640" y="3746520"/>
              <a:ext cx="1295280" cy="8395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77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2-28T18:29:03Z</dcterms:created>
  <dc:creator>Darwin</dc:creator>
  <dc:description/>
  <dc:language>en-US</dc:language>
  <cp:lastModifiedBy>x</cp:lastModifiedBy>
  <dcterms:modified xsi:type="dcterms:W3CDTF">2009-08-04T18:40:34Z</dcterms:modified>
  <cp:revision>194</cp:revision>
  <dc:subject/>
  <dc:title>Apresentação do PowerPoint</dc:title>
</cp:coreProperties>
</file>